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324" y="-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ED526-F20E-7A81-D70C-BE20AD1A98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715B0F-4BFE-F484-488D-E06F01F025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70E82E-4507-313F-BC28-E9F69D40B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45FB6-8649-62E8-3BA8-48E6E975D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1DB9BE-C5E5-E625-2921-5AD278C1B5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374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7E2E68-C935-9056-5913-6132546FC6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865A3A-12E0-259A-10F8-DD40DFF58E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962A58-463E-8C28-89CE-09E825996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6C9C0C-5DE0-58EC-FFF3-E9E8DC280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45D618-E592-786E-038A-BD78CDC52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251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19349B-FBBE-BA1A-3100-4236E03C8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32E587-C795-954B-C748-0344993B0A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DC3EE2-C19F-0F36-FAA6-86E2ADA64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41DD6C-2C8B-1806-BB24-3304B8C24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2CE626-568D-4A6B-8B9B-512DBA3F6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464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677F55-9119-D3F6-CC3D-B3478984A7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F9FCF4-09B6-4AB2-13F0-DD56BFC101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1B694A-8B6B-0A88-D26F-4792C8DFE1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AAF726-2AE0-5C4F-DFE2-0FF6BAEA6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803E36-DB2F-C148-F71A-D1B23B4D8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690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1A5E0-1C1A-8256-211C-07744ABA9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64D0BC-F715-BEBB-8B02-52C86C6AE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7A03B5-AEDB-6FE6-1D71-E413982D4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C870E9-D755-070F-DF4A-C3F5EC9C0B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31EB95-9654-1090-84FC-965EB4F9D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069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67772-29CD-31B6-66FD-164C6ECC2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CBC500-3B3C-7B16-29E4-51C6DD0391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16CE23-A2CA-1E0A-0407-ED0658907D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F249F-3BD9-1117-32D1-630A8EAF9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DE601C-4380-1ADD-A8B2-27BE899A5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E5281C-374D-E628-E607-180E24EF1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57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9EB8B-AA3A-C452-B577-5FDCBB359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FE927A-027B-1DC3-9140-3BFEA7366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36DE62-9EA2-81C4-6C78-AEF49B3B0E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67D8A91-1884-6A75-0EEB-80D8330D7C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48B31B5-23B4-D46C-37FB-D208E95C64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9B5216B-A268-1933-99BD-2BF3B106DF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276B05-67DB-CB7B-C7C1-50DBE4584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E18A46-564E-73B8-3579-665BA6C9B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519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47EF95-B423-E153-C1C1-65B9C91152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E17F5F-CF24-052C-2395-D92320DFB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06AC7B-F5FF-6BCB-65FB-6DDD8AFD7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3274AA-3D29-52DC-078A-253D93DF3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326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B2ED30-05DB-4938-020A-F8EC07DA7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E37202-A8E7-8321-7DD5-E89311212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6BB665-5D4F-FA4C-F75C-7E9771EED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4441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62041-899E-81CD-6762-97E099F7A8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85898A-D918-5B76-52E0-B29C0BF377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7B9C42-41C4-1920-D629-6D38D6D26A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10BBA7-ADB9-4A50-40E9-AA7193405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0FA141-3257-87F1-991A-FBFA9224DA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8615D-E339-B2F2-F316-3BB87071C6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766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C93561-E89B-A6E0-3E7B-C1B7188AE7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B24933-0704-68E8-8683-FD94B8F476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46F783-606C-F953-81BB-9E171522C1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03434D-4CD0-3657-6729-F499FAC36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FEEF6D-E330-69A2-CAE8-F2025796B4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32B220-C932-EE2D-32FF-C21CC6591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282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98A433-0800-70C3-3FA1-47BDBCC360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75190B-1CD6-126B-8A6F-793F5D9CA8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9B3FF2-1255-4FEC-14A0-EEFE015C8D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C6E22-4211-49E0-8B2A-D8C9AF8BC1A9}" type="datetimeFigureOut">
              <a:rPr lang="en-US" smtClean="0"/>
              <a:t>2/1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4BDE44-A672-51C9-BCEB-01A2B4F56B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E955F5-CEFE-4032-991A-4F4ABB2556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662E8E-F53A-4A43-8C00-2B505CA9D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281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4502A73A-EE59-7DC3-2709-F0106B34B497}"/>
              </a:ext>
            </a:extLst>
          </p:cNvPr>
          <p:cNvGrpSpPr/>
          <p:nvPr/>
        </p:nvGrpSpPr>
        <p:grpSpPr>
          <a:xfrm>
            <a:off x="1802063" y="165370"/>
            <a:ext cx="8606737" cy="6313251"/>
            <a:chOff x="1802063" y="165370"/>
            <a:chExt cx="8606737" cy="6313251"/>
          </a:xfrm>
        </p:grpSpPr>
        <p:sp>
          <p:nvSpPr>
            <p:cNvPr id="17" name="Freeform: Shape 16">
              <a:extLst>
                <a:ext uri="{FF2B5EF4-FFF2-40B4-BE49-F238E27FC236}">
                  <a16:creationId xmlns:a16="http://schemas.microsoft.com/office/drawing/2014/main" id="{9239DE76-0492-1DB7-664F-B8A443F9B8E8}"/>
                </a:ext>
              </a:extLst>
            </p:cNvPr>
            <p:cNvSpPr/>
            <p:nvPr/>
          </p:nvSpPr>
          <p:spPr>
            <a:xfrm>
              <a:off x="7826779" y="165370"/>
              <a:ext cx="2582021" cy="6313251"/>
            </a:xfrm>
            <a:custGeom>
              <a:avLst/>
              <a:gdLst>
                <a:gd name="connsiteX0" fmla="*/ 0 w 2582021"/>
                <a:gd name="connsiteY0" fmla="*/ 258202 h 6313251"/>
                <a:gd name="connsiteX1" fmla="*/ 258202 w 2582021"/>
                <a:gd name="connsiteY1" fmla="*/ 0 h 6313251"/>
                <a:gd name="connsiteX2" fmla="*/ 2323819 w 2582021"/>
                <a:gd name="connsiteY2" fmla="*/ 0 h 6313251"/>
                <a:gd name="connsiteX3" fmla="*/ 2582021 w 2582021"/>
                <a:gd name="connsiteY3" fmla="*/ 258202 h 6313251"/>
                <a:gd name="connsiteX4" fmla="*/ 2582021 w 2582021"/>
                <a:gd name="connsiteY4" fmla="*/ 6055049 h 6313251"/>
                <a:gd name="connsiteX5" fmla="*/ 2323819 w 2582021"/>
                <a:gd name="connsiteY5" fmla="*/ 6313251 h 6313251"/>
                <a:gd name="connsiteX6" fmla="*/ 258202 w 2582021"/>
                <a:gd name="connsiteY6" fmla="*/ 6313251 h 6313251"/>
                <a:gd name="connsiteX7" fmla="*/ 0 w 2582021"/>
                <a:gd name="connsiteY7" fmla="*/ 6055049 h 6313251"/>
                <a:gd name="connsiteX8" fmla="*/ 0 w 2582021"/>
                <a:gd name="connsiteY8" fmla="*/ 258202 h 63132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82021" h="6313251">
                  <a:moveTo>
                    <a:pt x="0" y="258202"/>
                  </a:moveTo>
                  <a:cubicBezTo>
                    <a:pt x="0" y="115601"/>
                    <a:pt x="115601" y="0"/>
                    <a:pt x="258202" y="0"/>
                  </a:cubicBezTo>
                  <a:lnTo>
                    <a:pt x="2323819" y="0"/>
                  </a:lnTo>
                  <a:cubicBezTo>
                    <a:pt x="2466420" y="0"/>
                    <a:pt x="2582021" y="115601"/>
                    <a:pt x="2582021" y="258202"/>
                  </a:cubicBezTo>
                  <a:lnTo>
                    <a:pt x="2582021" y="6055049"/>
                  </a:lnTo>
                  <a:cubicBezTo>
                    <a:pt x="2582021" y="6197650"/>
                    <a:pt x="2466420" y="6313251"/>
                    <a:pt x="2323819" y="6313251"/>
                  </a:cubicBezTo>
                  <a:lnTo>
                    <a:pt x="258202" y="6313251"/>
                  </a:lnTo>
                  <a:cubicBezTo>
                    <a:pt x="115601" y="6313251"/>
                    <a:pt x="0" y="6197650"/>
                    <a:pt x="0" y="6055049"/>
                  </a:cubicBezTo>
                  <a:lnTo>
                    <a:pt x="0" y="258202"/>
                  </a:lnTo>
                  <a:close/>
                </a:path>
              </a:pathLst>
            </a:custGeom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spcFirstLastPara="0" vert="horz" wrap="square" lIns="263144" tIns="263144" rIns="263144" bIns="4682420" numCol="1" spcCol="1270" anchor="ctr" anchorCtr="0">
              <a:noAutofit/>
            </a:bodyPr>
            <a:lstStyle/>
            <a:p>
              <a:pPr marL="0" lvl="0" indent="0" algn="ctr" defTabSz="16446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3700" kern="1200" dirty="0">
                  <a:solidFill>
                    <a:schemeClr val="tx1"/>
                  </a:solidFill>
                </a:rPr>
                <a:t>Output</a:t>
              </a:r>
            </a:p>
          </p:txBody>
        </p:sp>
        <p:sp>
          <p:nvSpPr>
            <p:cNvPr id="18" name="Freeform: Shape 17">
              <a:extLst>
                <a:ext uri="{FF2B5EF4-FFF2-40B4-BE49-F238E27FC236}">
                  <a16:creationId xmlns:a16="http://schemas.microsoft.com/office/drawing/2014/main" id="{4940C2F1-6916-338A-6C86-BF6DB370309A}"/>
                </a:ext>
              </a:extLst>
            </p:cNvPr>
            <p:cNvSpPr/>
            <p:nvPr/>
          </p:nvSpPr>
          <p:spPr>
            <a:xfrm>
              <a:off x="4814421" y="165370"/>
              <a:ext cx="2582021" cy="6313251"/>
            </a:xfrm>
            <a:custGeom>
              <a:avLst/>
              <a:gdLst>
                <a:gd name="connsiteX0" fmla="*/ 0 w 2582021"/>
                <a:gd name="connsiteY0" fmla="*/ 258202 h 6313251"/>
                <a:gd name="connsiteX1" fmla="*/ 258202 w 2582021"/>
                <a:gd name="connsiteY1" fmla="*/ 0 h 6313251"/>
                <a:gd name="connsiteX2" fmla="*/ 2323819 w 2582021"/>
                <a:gd name="connsiteY2" fmla="*/ 0 h 6313251"/>
                <a:gd name="connsiteX3" fmla="*/ 2582021 w 2582021"/>
                <a:gd name="connsiteY3" fmla="*/ 258202 h 6313251"/>
                <a:gd name="connsiteX4" fmla="*/ 2582021 w 2582021"/>
                <a:gd name="connsiteY4" fmla="*/ 6055049 h 6313251"/>
                <a:gd name="connsiteX5" fmla="*/ 2323819 w 2582021"/>
                <a:gd name="connsiteY5" fmla="*/ 6313251 h 6313251"/>
                <a:gd name="connsiteX6" fmla="*/ 258202 w 2582021"/>
                <a:gd name="connsiteY6" fmla="*/ 6313251 h 6313251"/>
                <a:gd name="connsiteX7" fmla="*/ 0 w 2582021"/>
                <a:gd name="connsiteY7" fmla="*/ 6055049 h 6313251"/>
                <a:gd name="connsiteX8" fmla="*/ 0 w 2582021"/>
                <a:gd name="connsiteY8" fmla="*/ 258202 h 63132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82021" h="6313251">
                  <a:moveTo>
                    <a:pt x="0" y="258202"/>
                  </a:moveTo>
                  <a:cubicBezTo>
                    <a:pt x="0" y="115601"/>
                    <a:pt x="115601" y="0"/>
                    <a:pt x="258202" y="0"/>
                  </a:cubicBezTo>
                  <a:lnTo>
                    <a:pt x="2323819" y="0"/>
                  </a:lnTo>
                  <a:cubicBezTo>
                    <a:pt x="2466420" y="0"/>
                    <a:pt x="2582021" y="115601"/>
                    <a:pt x="2582021" y="258202"/>
                  </a:cubicBezTo>
                  <a:lnTo>
                    <a:pt x="2582021" y="6055049"/>
                  </a:lnTo>
                  <a:cubicBezTo>
                    <a:pt x="2582021" y="6197650"/>
                    <a:pt x="2466420" y="6313251"/>
                    <a:pt x="2323819" y="6313251"/>
                  </a:cubicBezTo>
                  <a:lnTo>
                    <a:pt x="258202" y="6313251"/>
                  </a:lnTo>
                  <a:cubicBezTo>
                    <a:pt x="115601" y="6313251"/>
                    <a:pt x="0" y="6197650"/>
                    <a:pt x="0" y="6055049"/>
                  </a:cubicBezTo>
                  <a:lnTo>
                    <a:pt x="0" y="258202"/>
                  </a:lnTo>
                  <a:close/>
                </a:path>
              </a:pathLst>
            </a:custGeom>
          </p:spPr>
          <p:style>
            <a:lnRef idx="3">
              <a:schemeClr val="lt1"/>
            </a:lnRef>
            <a:fillRef idx="1">
              <a:schemeClr val="accent4"/>
            </a:fillRef>
            <a:effectRef idx="1">
              <a:schemeClr val="accent4"/>
            </a:effectRef>
            <a:fontRef idx="minor">
              <a:schemeClr val="lt1"/>
            </a:fontRef>
          </p:style>
          <p:txBody>
            <a:bodyPr spcFirstLastPara="0" vert="horz" wrap="square" lIns="263144" tIns="263144" rIns="263144" bIns="4682420" numCol="1" spcCol="1270" anchor="ctr" anchorCtr="0">
              <a:noAutofit/>
            </a:bodyPr>
            <a:lstStyle/>
            <a:p>
              <a:pPr marL="0" lvl="0" indent="0" algn="ctr" defTabSz="16446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3700" kern="1200" dirty="0">
                  <a:solidFill>
                    <a:schemeClr val="tx1"/>
                  </a:solidFill>
                </a:rPr>
                <a:t>Simulation</a:t>
              </a:r>
            </a:p>
          </p:txBody>
        </p:sp>
        <p:sp>
          <p:nvSpPr>
            <p:cNvPr id="19" name="Freeform: Shape 18">
              <a:extLst>
                <a:ext uri="{FF2B5EF4-FFF2-40B4-BE49-F238E27FC236}">
                  <a16:creationId xmlns:a16="http://schemas.microsoft.com/office/drawing/2014/main" id="{5B3CB5B6-113D-4C24-F014-3DAC8A6A32A5}"/>
                </a:ext>
              </a:extLst>
            </p:cNvPr>
            <p:cNvSpPr/>
            <p:nvPr/>
          </p:nvSpPr>
          <p:spPr>
            <a:xfrm>
              <a:off x="1802063" y="165370"/>
              <a:ext cx="2582021" cy="6313251"/>
            </a:xfrm>
            <a:custGeom>
              <a:avLst/>
              <a:gdLst>
                <a:gd name="connsiteX0" fmla="*/ 0 w 2582021"/>
                <a:gd name="connsiteY0" fmla="*/ 258202 h 6313251"/>
                <a:gd name="connsiteX1" fmla="*/ 258202 w 2582021"/>
                <a:gd name="connsiteY1" fmla="*/ 0 h 6313251"/>
                <a:gd name="connsiteX2" fmla="*/ 2323819 w 2582021"/>
                <a:gd name="connsiteY2" fmla="*/ 0 h 6313251"/>
                <a:gd name="connsiteX3" fmla="*/ 2582021 w 2582021"/>
                <a:gd name="connsiteY3" fmla="*/ 258202 h 6313251"/>
                <a:gd name="connsiteX4" fmla="*/ 2582021 w 2582021"/>
                <a:gd name="connsiteY4" fmla="*/ 6055049 h 6313251"/>
                <a:gd name="connsiteX5" fmla="*/ 2323819 w 2582021"/>
                <a:gd name="connsiteY5" fmla="*/ 6313251 h 6313251"/>
                <a:gd name="connsiteX6" fmla="*/ 258202 w 2582021"/>
                <a:gd name="connsiteY6" fmla="*/ 6313251 h 6313251"/>
                <a:gd name="connsiteX7" fmla="*/ 0 w 2582021"/>
                <a:gd name="connsiteY7" fmla="*/ 6055049 h 6313251"/>
                <a:gd name="connsiteX8" fmla="*/ 0 w 2582021"/>
                <a:gd name="connsiteY8" fmla="*/ 258202 h 63132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582021" h="6313251">
                  <a:moveTo>
                    <a:pt x="0" y="258202"/>
                  </a:moveTo>
                  <a:cubicBezTo>
                    <a:pt x="0" y="115601"/>
                    <a:pt x="115601" y="0"/>
                    <a:pt x="258202" y="0"/>
                  </a:cubicBezTo>
                  <a:lnTo>
                    <a:pt x="2323819" y="0"/>
                  </a:lnTo>
                  <a:cubicBezTo>
                    <a:pt x="2466420" y="0"/>
                    <a:pt x="2582021" y="115601"/>
                    <a:pt x="2582021" y="258202"/>
                  </a:cubicBezTo>
                  <a:lnTo>
                    <a:pt x="2582021" y="6055049"/>
                  </a:lnTo>
                  <a:cubicBezTo>
                    <a:pt x="2582021" y="6197650"/>
                    <a:pt x="2466420" y="6313251"/>
                    <a:pt x="2323819" y="6313251"/>
                  </a:cubicBezTo>
                  <a:lnTo>
                    <a:pt x="258202" y="6313251"/>
                  </a:lnTo>
                  <a:cubicBezTo>
                    <a:pt x="115601" y="6313251"/>
                    <a:pt x="0" y="6197650"/>
                    <a:pt x="0" y="6055049"/>
                  </a:cubicBezTo>
                  <a:lnTo>
                    <a:pt x="0" y="258202"/>
                  </a:lnTo>
                  <a:close/>
                </a:path>
              </a:pathLst>
            </a:custGeom>
          </p:spPr>
          <p:style>
            <a:lnRef idx="0">
              <a:schemeClr val="accen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tint val="40000"/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tint val="4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263144" tIns="263144" rIns="263144" bIns="4682420" numCol="1" spcCol="1270" anchor="ctr" anchorCtr="0">
              <a:noAutofit/>
            </a:bodyPr>
            <a:lstStyle/>
            <a:p>
              <a:pPr marL="0" lvl="0" indent="0" algn="ctr" defTabSz="16446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3700" kern="1200">
                  <a:solidFill>
                    <a:schemeClr val="tx1"/>
                  </a:solidFill>
                </a:rPr>
                <a:t>Input</a:t>
              </a:r>
              <a:endParaRPr lang="en-US" sz="3700" kern="1200" dirty="0">
                <a:solidFill>
                  <a:schemeClr val="tx1"/>
                </a:solidFill>
              </a:endParaRPr>
            </a:p>
          </p:txBody>
        </p:sp>
        <p:sp>
          <p:nvSpPr>
            <p:cNvPr id="20" name="Freeform: Shape 19">
              <a:extLst>
                <a:ext uri="{FF2B5EF4-FFF2-40B4-BE49-F238E27FC236}">
                  <a16:creationId xmlns:a16="http://schemas.microsoft.com/office/drawing/2014/main" id="{33EE13DD-7582-F4FE-AE56-59D6267B46C2}"/>
                </a:ext>
              </a:extLst>
            </p:cNvPr>
            <p:cNvSpPr/>
            <p:nvPr/>
          </p:nvSpPr>
          <p:spPr>
            <a:xfrm>
              <a:off x="1922301" y="3268494"/>
              <a:ext cx="2344361" cy="2723870"/>
            </a:xfrm>
            <a:custGeom>
              <a:avLst/>
              <a:gdLst>
                <a:gd name="connsiteX0" fmla="*/ 0 w 2480934"/>
                <a:gd name="connsiteY0" fmla="*/ 248093 h 2723870"/>
                <a:gd name="connsiteX1" fmla="*/ 248093 w 2480934"/>
                <a:gd name="connsiteY1" fmla="*/ 0 h 2723870"/>
                <a:gd name="connsiteX2" fmla="*/ 2232841 w 2480934"/>
                <a:gd name="connsiteY2" fmla="*/ 0 h 2723870"/>
                <a:gd name="connsiteX3" fmla="*/ 2480934 w 2480934"/>
                <a:gd name="connsiteY3" fmla="*/ 248093 h 2723870"/>
                <a:gd name="connsiteX4" fmla="*/ 2480934 w 2480934"/>
                <a:gd name="connsiteY4" fmla="*/ 2475777 h 2723870"/>
                <a:gd name="connsiteX5" fmla="*/ 2232841 w 2480934"/>
                <a:gd name="connsiteY5" fmla="*/ 2723870 h 2723870"/>
                <a:gd name="connsiteX6" fmla="*/ 248093 w 2480934"/>
                <a:gd name="connsiteY6" fmla="*/ 2723870 h 2723870"/>
                <a:gd name="connsiteX7" fmla="*/ 0 w 2480934"/>
                <a:gd name="connsiteY7" fmla="*/ 2475777 h 2723870"/>
                <a:gd name="connsiteX8" fmla="*/ 0 w 2480934"/>
                <a:gd name="connsiteY8" fmla="*/ 248093 h 272387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480934" h="2723870">
                  <a:moveTo>
                    <a:pt x="0" y="248093"/>
                  </a:moveTo>
                  <a:cubicBezTo>
                    <a:pt x="0" y="111075"/>
                    <a:pt x="111075" y="0"/>
                    <a:pt x="248093" y="0"/>
                  </a:cubicBezTo>
                  <a:lnTo>
                    <a:pt x="2232841" y="0"/>
                  </a:lnTo>
                  <a:cubicBezTo>
                    <a:pt x="2369859" y="0"/>
                    <a:pt x="2480934" y="111075"/>
                    <a:pt x="2480934" y="248093"/>
                  </a:cubicBezTo>
                  <a:lnTo>
                    <a:pt x="2480934" y="2475777"/>
                  </a:lnTo>
                  <a:cubicBezTo>
                    <a:pt x="2480934" y="2612795"/>
                    <a:pt x="2369859" y="2723870"/>
                    <a:pt x="2232841" y="2723870"/>
                  </a:cubicBezTo>
                  <a:lnTo>
                    <a:pt x="248093" y="2723870"/>
                  </a:lnTo>
                  <a:cubicBezTo>
                    <a:pt x="111075" y="2723870"/>
                    <a:pt x="0" y="2612795"/>
                    <a:pt x="0" y="2475777"/>
                  </a:cubicBezTo>
                  <a:lnTo>
                    <a:pt x="0" y="248093"/>
                  </a:lnTo>
                  <a:close/>
                </a:path>
              </a:pathLst>
            </a:cu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spcFirstLastPara="0" vert="horz" wrap="square" lIns="82189" tIns="82189" rIns="82189" bIns="82189" numCol="1" spcCol="1270" anchor="b" anchorCtr="1">
              <a:noAutofit/>
            </a:bodyPr>
            <a:lstStyle/>
            <a:p>
              <a:pPr marL="0" lvl="0" indent="0" algn="l" defTabSz="844550" rtl="0" eaLnBrk="1" latinLnBrk="0" hangingPunct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Twenty-five experts were consulted and suggestions on selected parameters were </a:t>
              </a:r>
              <a:r>
                <a:rPr lang="en-US" sz="15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s</a:t>
              </a: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ought:</a:t>
              </a:r>
            </a:p>
            <a:p>
              <a:pPr marL="0" lvl="0" indent="0" algn="l" defTabSz="844550" rtl="0" eaLnBrk="1" latinLnBrk="0" hangingPunct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initial infected sites</a:t>
              </a:r>
            </a:p>
            <a:p>
              <a:pPr marL="0" lvl="0" indent="0" algn="l" defTabSz="844550" rtl="0" eaLnBrk="1" latinLnBrk="0" hangingPunct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the probability of initial infected adopter for each network</a:t>
              </a:r>
            </a:p>
            <a:p>
              <a:pPr marL="0" lvl="0" indent="0" algn="l" defTabSz="844550" rtl="0" eaLnBrk="1" latinLnBrk="0" hangingPunct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transmission probability</a:t>
              </a:r>
            </a:p>
            <a:p>
              <a:pPr marL="0" lvl="0" algn="ctr" defTabSz="8001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1800" kern="12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22" name="Freeform: Shape 21">
              <a:extLst>
                <a:ext uri="{FF2B5EF4-FFF2-40B4-BE49-F238E27FC236}">
                  <a16:creationId xmlns:a16="http://schemas.microsoft.com/office/drawing/2014/main" id="{C5E23DAA-60FC-5412-4882-30C4E269441B}"/>
                </a:ext>
              </a:extLst>
            </p:cNvPr>
            <p:cNvSpPr/>
            <p:nvPr/>
          </p:nvSpPr>
          <p:spPr>
            <a:xfrm>
              <a:off x="5013987" y="3083668"/>
              <a:ext cx="2151684" cy="1075842"/>
            </a:xfrm>
            <a:custGeom>
              <a:avLst/>
              <a:gdLst>
                <a:gd name="connsiteX0" fmla="*/ 0 w 2151684"/>
                <a:gd name="connsiteY0" fmla="*/ 107584 h 1075842"/>
                <a:gd name="connsiteX1" fmla="*/ 107584 w 2151684"/>
                <a:gd name="connsiteY1" fmla="*/ 0 h 1075842"/>
                <a:gd name="connsiteX2" fmla="*/ 2044100 w 2151684"/>
                <a:gd name="connsiteY2" fmla="*/ 0 h 1075842"/>
                <a:gd name="connsiteX3" fmla="*/ 2151684 w 2151684"/>
                <a:gd name="connsiteY3" fmla="*/ 107584 h 1075842"/>
                <a:gd name="connsiteX4" fmla="*/ 2151684 w 2151684"/>
                <a:gd name="connsiteY4" fmla="*/ 968258 h 1075842"/>
                <a:gd name="connsiteX5" fmla="*/ 2044100 w 2151684"/>
                <a:gd name="connsiteY5" fmla="*/ 1075842 h 1075842"/>
                <a:gd name="connsiteX6" fmla="*/ 107584 w 2151684"/>
                <a:gd name="connsiteY6" fmla="*/ 1075842 h 1075842"/>
                <a:gd name="connsiteX7" fmla="*/ 0 w 2151684"/>
                <a:gd name="connsiteY7" fmla="*/ 968258 h 1075842"/>
                <a:gd name="connsiteX8" fmla="*/ 0 w 2151684"/>
                <a:gd name="connsiteY8" fmla="*/ 107584 h 10758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151684" h="1075842">
                  <a:moveTo>
                    <a:pt x="0" y="107584"/>
                  </a:moveTo>
                  <a:cubicBezTo>
                    <a:pt x="0" y="48167"/>
                    <a:pt x="48167" y="0"/>
                    <a:pt x="107584" y="0"/>
                  </a:cubicBezTo>
                  <a:lnTo>
                    <a:pt x="2044100" y="0"/>
                  </a:lnTo>
                  <a:cubicBezTo>
                    <a:pt x="2103517" y="0"/>
                    <a:pt x="2151684" y="48167"/>
                    <a:pt x="2151684" y="107584"/>
                  </a:cubicBezTo>
                  <a:lnTo>
                    <a:pt x="2151684" y="968258"/>
                  </a:lnTo>
                  <a:cubicBezTo>
                    <a:pt x="2151684" y="1027675"/>
                    <a:pt x="2103517" y="1075842"/>
                    <a:pt x="2044100" y="1075842"/>
                  </a:cubicBezTo>
                  <a:lnTo>
                    <a:pt x="107584" y="1075842"/>
                  </a:lnTo>
                  <a:cubicBezTo>
                    <a:pt x="48167" y="1075842"/>
                    <a:pt x="0" y="1027675"/>
                    <a:pt x="0" y="968258"/>
                  </a:cubicBezTo>
                  <a:lnTo>
                    <a:pt x="0" y="107584"/>
                  </a:lnTo>
                  <a:close/>
                </a:path>
              </a:pathLst>
            </a:custGeom>
            <a:ln>
              <a:solidFill>
                <a:schemeClr val="bg1"/>
              </a:solidFill>
            </a:ln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spcFirstLastPara="0" vert="horz" wrap="square" lIns="53100" tIns="53100" rIns="53100" bIns="53100" numCol="1" spcCol="1270" anchor="ctr" anchorCtr="0">
              <a:noAutofit/>
            </a:bodyPr>
            <a:lstStyle/>
            <a:p>
              <a:pPr marL="0" lvl="0" indent="0" algn="ctr" defTabSz="1511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3400" kern="1200" dirty="0">
                  <a:solidFill>
                    <a:schemeClr val="tx1"/>
                  </a:solidFill>
                </a:rPr>
                <a:t>Diffusion models </a:t>
              </a:r>
            </a:p>
          </p:txBody>
        </p:sp>
        <p:sp>
          <p:nvSpPr>
            <p:cNvPr id="24" name="Freeform: Shape 23">
              <a:extLst>
                <a:ext uri="{FF2B5EF4-FFF2-40B4-BE49-F238E27FC236}">
                  <a16:creationId xmlns:a16="http://schemas.microsoft.com/office/drawing/2014/main" id="{DF49F378-6E8A-D3F9-447D-35479950607A}"/>
                </a:ext>
              </a:extLst>
            </p:cNvPr>
            <p:cNvSpPr/>
            <p:nvPr/>
          </p:nvSpPr>
          <p:spPr>
            <a:xfrm>
              <a:off x="8094833" y="2067065"/>
              <a:ext cx="2151684" cy="2723870"/>
            </a:xfrm>
            <a:custGeom>
              <a:avLst/>
              <a:gdLst>
                <a:gd name="connsiteX0" fmla="*/ 0 w 2151684"/>
                <a:gd name="connsiteY0" fmla="*/ 107584 h 1075842"/>
                <a:gd name="connsiteX1" fmla="*/ 107584 w 2151684"/>
                <a:gd name="connsiteY1" fmla="*/ 0 h 1075842"/>
                <a:gd name="connsiteX2" fmla="*/ 2044100 w 2151684"/>
                <a:gd name="connsiteY2" fmla="*/ 0 h 1075842"/>
                <a:gd name="connsiteX3" fmla="*/ 2151684 w 2151684"/>
                <a:gd name="connsiteY3" fmla="*/ 107584 h 1075842"/>
                <a:gd name="connsiteX4" fmla="*/ 2151684 w 2151684"/>
                <a:gd name="connsiteY4" fmla="*/ 968258 h 1075842"/>
                <a:gd name="connsiteX5" fmla="*/ 2044100 w 2151684"/>
                <a:gd name="connsiteY5" fmla="*/ 1075842 h 1075842"/>
                <a:gd name="connsiteX6" fmla="*/ 107584 w 2151684"/>
                <a:gd name="connsiteY6" fmla="*/ 1075842 h 1075842"/>
                <a:gd name="connsiteX7" fmla="*/ 0 w 2151684"/>
                <a:gd name="connsiteY7" fmla="*/ 968258 h 1075842"/>
                <a:gd name="connsiteX8" fmla="*/ 0 w 2151684"/>
                <a:gd name="connsiteY8" fmla="*/ 107584 h 107584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151684" h="1075842">
                  <a:moveTo>
                    <a:pt x="0" y="107584"/>
                  </a:moveTo>
                  <a:cubicBezTo>
                    <a:pt x="0" y="48167"/>
                    <a:pt x="48167" y="0"/>
                    <a:pt x="107584" y="0"/>
                  </a:cubicBezTo>
                  <a:lnTo>
                    <a:pt x="2044100" y="0"/>
                  </a:lnTo>
                  <a:cubicBezTo>
                    <a:pt x="2103517" y="0"/>
                    <a:pt x="2151684" y="48167"/>
                    <a:pt x="2151684" y="107584"/>
                  </a:cubicBezTo>
                  <a:lnTo>
                    <a:pt x="2151684" y="968258"/>
                  </a:lnTo>
                  <a:cubicBezTo>
                    <a:pt x="2151684" y="1027675"/>
                    <a:pt x="2103517" y="1075842"/>
                    <a:pt x="2044100" y="1075842"/>
                  </a:cubicBezTo>
                  <a:lnTo>
                    <a:pt x="107584" y="1075842"/>
                  </a:lnTo>
                  <a:cubicBezTo>
                    <a:pt x="48167" y="1075842"/>
                    <a:pt x="0" y="1027675"/>
                    <a:pt x="0" y="968258"/>
                  </a:cubicBezTo>
                  <a:lnTo>
                    <a:pt x="0" y="107584"/>
                  </a:lnTo>
                  <a:close/>
                </a:path>
              </a:pathLst>
            </a:custGeom>
          </p:spPr>
          <p:style>
            <a:lnRef idx="3">
              <a:schemeClr val="lt1"/>
            </a:lnRef>
            <a:fillRef idx="1">
              <a:schemeClr val="accent6"/>
            </a:fillRef>
            <a:effectRef idx="1">
              <a:schemeClr val="accent6"/>
            </a:effectRef>
            <a:fontRef idx="minor">
              <a:schemeClr val="lt1"/>
            </a:fontRef>
          </p:style>
          <p:txBody>
            <a:bodyPr spcFirstLastPara="0" vert="horz" wrap="square" lIns="53100" tIns="53100" rIns="53100" bIns="53100" numCol="1" spcCol="1270" anchor="ctr" anchorCtr="0">
              <a:noAutofit/>
            </a:bodyPr>
            <a:lstStyle/>
            <a:p>
              <a:pPr marL="0" lvl="0" indent="0" defTabSz="1511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Diffusion model of live pig movement at the provincial and district levels</a:t>
              </a:r>
            </a:p>
            <a:p>
              <a:pPr marL="0" lvl="0" indent="0" defTabSz="1511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Diffusion model </a:t>
              </a:r>
              <a:r>
                <a:rPr lang="en-US" sz="1500" kern="120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of carcasses </a:t>
              </a: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at the provincial and </a:t>
              </a:r>
              <a:r>
                <a:rPr lang="en-US" sz="1500" kern="120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district levels</a:t>
              </a:r>
              <a:endParaRPr lang="en-US" sz="1500" kern="1200" dirty="0">
                <a:solidFill>
                  <a:schemeClr val="tx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  <a:p>
              <a:pPr marL="0" lvl="0" indent="0" defTabSz="15113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1500" kern="1200" dirty="0">
                  <a:solidFill>
                    <a:schemeClr val="tx1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- Diffusion model with parameter changes</a:t>
              </a:r>
            </a:p>
          </p:txBody>
        </p:sp>
      </p:grp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F5F74B78-68CA-CC60-1C74-1775E3F6AF85}"/>
              </a:ext>
            </a:extLst>
          </p:cNvPr>
          <p:cNvSpPr/>
          <p:nvPr/>
        </p:nvSpPr>
        <p:spPr>
          <a:xfrm>
            <a:off x="1935803" y="1799616"/>
            <a:ext cx="2344361" cy="1189389"/>
          </a:xfrm>
          <a:prstGeom prst="roundRect">
            <a:avLst>
              <a:gd name="adj" fmla="val 10000"/>
            </a:avLst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spcFirstLastPara="0" vert="horz" wrap="square" lIns="82189" tIns="82189" rIns="82189" bIns="82189" numCol="1" spcCol="1270" anchor="b" anchorCtr="1">
            <a:noAutofit/>
          </a:bodyPr>
          <a:lstStyle/>
          <a:p>
            <a:r>
              <a:rPr lang="en-US" sz="1500" dirty="0">
                <a:solidFill>
                  <a:schemeClr val="tx1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Results of movement data in the year 2019 were evaluated through expert consultation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952DA440-3484-47CA-189C-2DBCA20D288A}"/>
              </a:ext>
            </a:extLst>
          </p:cNvPr>
          <p:cNvCxnSpPr>
            <a:cxnSpLocks/>
          </p:cNvCxnSpPr>
          <p:nvPr/>
        </p:nvCxnSpPr>
        <p:spPr>
          <a:xfrm>
            <a:off x="3083671" y="2989005"/>
            <a:ext cx="0" cy="2989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04E943A-E7F8-A348-1661-A32DDE77D301}"/>
              </a:ext>
            </a:extLst>
          </p:cNvPr>
          <p:cNvCxnSpPr>
            <a:cxnSpLocks/>
          </p:cNvCxnSpPr>
          <p:nvPr/>
        </p:nvCxnSpPr>
        <p:spPr>
          <a:xfrm flipV="1">
            <a:off x="4328913" y="3725694"/>
            <a:ext cx="675995" cy="719846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001FEC28-3DD6-A3FA-3C44-7670A6CEDAD0}"/>
              </a:ext>
            </a:extLst>
          </p:cNvPr>
          <p:cNvCxnSpPr>
            <a:cxnSpLocks/>
          </p:cNvCxnSpPr>
          <p:nvPr/>
        </p:nvCxnSpPr>
        <p:spPr>
          <a:xfrm>
            <a:off x="7174750" y="3649746"/>
            <a:ext cx="920083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7377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7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P</dc:creator>
  <cp:lastModifiedBy>Author</cp:lastModifiedBy>
  <cp:revision>6</cp:revision>
  <dcterms:created xsi:type="dcterms:W3CDTF">2023-02-06T16:41:43Z</dcterms:created>
  <dcterms:modified xsi:type="dcterms:W3CDTF">2023-02-15T12:16:12Z</dcterms:modified>
</cp:coreProperties>
</file>